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0"/>
  </p:notesMasterIdLst>
  <p:sldIdLst>
    <p:sldId id="1370" r:id="rId5"/>
    <p:sldId id="1369" r:id="rId6"/>
    <p:sldId id="1367" r:id="rId7"/>
    <p:sldId id="1363" r:id="rId8"/>
    <p:sldId id="1371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0AB79370-0E71-4CC2-98CD-A1AE62853165}">
          <p14:sldIdLst>
            <p14:sldId id="1370"/>
            <p14:sldId id="1369"/>
            <p14:sldId id="1367"/>
            <p14:sldId id="1363"/>
            <p14:sldId id="137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F13B4"/>
    <a:srgbClr val="A50F90"/>
    <a:srgbClr val="EE42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7602" autoAdjust="0"/>
  </p:normalViewPr>
  <p:slideViewPr>
    <p:cSldViewPr snapToGrid="0">
      <p:cViewPr varScale="1">
        <p:scale>
          <a:sx n="69" d="100"/>
          <a:sy n="69" d="100"/>
        </p:scale>
        <p:origin x="5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CC44D0-89A8-4237-9FAF-4B9788F1F6D6}" type="datetimeFigureOut">
              <a:rPr lang="en-US" smtClean="0"/>
              <a:t>5/30/2024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DDC6E9-6A46-4309-A94A-879556902C0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299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DDC6E9-6A46-4309-A94A-879556902C0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473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DDC6E9-6A46-4309-A94A-879556902C0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60871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CDDC6E9-6A46-4309-A94A-879556902C0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2301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r le style des sous-titres du masque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604471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89610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34075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39930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05586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39089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5513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54277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92273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81714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5714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2F2606-AEB1-4B79-AD1E-637F36A38D3A}" type="datetimeFigureOut">
              <a:rPr lang="en-CA" smtClean="0"/>
              <a:t>2024-05-30</a:t>
            </a:fld>
            <a:endParaRPr lang="en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BB5BF-599C-414E-8B7A-8EA4E12FBF1E}" type="slidenum">
              <a:rPr lang="en-CA" smtClean="0"/>
              <a:t>‹N°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61938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4289" y="680931"/>
            <a:ext cx="7247107" cy="4873558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 3"/>
          <p:cNvSpPr/>
          <p:nvPr/>
        </p:nvSpPr>
        <p:spPr>
          <a:xfrm>
            <a:off x="68094" y="5947040"/>
            <a:ext cx="11926110" cy="8817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 S1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ffect of mobile phase buffer (phosphate or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is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pH (6.5 or 7.5) on the separation of different RNA species (RNA ladder, EGFP mRNA and Cas9 mRNA). (*) corresponds to the species composed of 200 and 500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while (</a:t>
            </a:r>
            <a:r>
              <a:rPr lang="en-US" baseline="30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corresponds to the species composed of 4000 and 6000 nt. </a:t>
            </a:r>
            <a:endParaRPr lang="en-CA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C8467C22-0882-4688-95D9-EC703FB7764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1947"/>
          <a:stretch/>
        </p:blipFill>
        <p:spPr>
          <a:xfrm>
            <a:off x="3041403" y="304455"/>
            <a:ext cx="7532564" cy="227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47608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C8467C22-0882-4688-95D9-EC703FB776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1044" y="1350895"/>
            <a:ext cx="10365174" cy="38808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66F98569-3827-42EC-A0FB-8E4325D39F94}"/>
              </a:ext>
            </a:extLst>
          </p:cNvPr>
          <p:cNvSpPr/>
          <p:nvPr/>
        </p:nvSpPr>
        <p:spPr>
          <a:xfrm>
            <a:off x="142" y="6211669"/>
            <a:ext cx="12191858" cy="6186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  <a:defRPr/>
            </a:pPr>
            <a:r>
              <a:rPr lang="en-CA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en-CA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aluation of isopropanol addition (5 and 10% IPA) to the mobile phase for three different samples,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mely RNA ladder, EGFP mRNA (996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Cas9 mRNA (4521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5478359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7EDB54D9-0F1C-4F37-9D93-EA729B9F53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4275" y="1488600"/>
            <a:ext cx="9063450" cy="3880800"/>
          </a:xfrm>
          <a:prstGeom prst="rect">
            <a:avLst/>
          </a:prstGeom>
        </p:spPr>
      </p:pic>
      <p:cxnSp>
        <p:nvCxnSpPr>
          <p:cNvPr id="3" name="Connecteur droit avec flèche 2"/>
          <p:cNvCxnSpPr/>
          <p:nvPr/>
        </p:nvCxnSpPr>
        <p:spPr>
          <a:xfrm>
            <a:off x="8963025" y="4781550"/>
            <a:ext cx="77280" cy="176949"/>
          </a:xfrm>
          <a:prstGeom prst="straightConnector1">
            <a:avLst/>
          </a:prstGeom>
          <a:ln w="28575">
            <a:solidFill>
              <a:srgbClr val="CF13B4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droit avec flèche 7"/>
          <p:cNvCxnSpPr/>
          <p:nvPr/>
        </p:nvCxnSpPr>
        <p:spPr>
          <a:xfrm flipH="1">
            <a:off x="9316530" y="4781550"/>
            <a:ext cx="160845" cy="152400"/>
          </a:xfrm>
          <a:prstGeom prst="straightConnector1">
            <a:avLst/>
          </a:prstGeom>
          <a:ln w="28575">
            <a:solidFill>
              <a:srgbClr val="CF13B4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66F98569-3827-42EC-A0FB-8E4325D39F94}"/>
              </a:ext>
            </a:extLst>
          </p:cNvPr>
          <p:cNvSpPr/>
          <p:nvPr/>
        </p:nvSpPr>
        <p:spPr>
          <a:xfrm>
            <a:off x="142" y="6211669"/>
            <a:ext cx="121918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CA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: </a:t>
            </a:r>
            <a:r>
              <a:rPr lang="en-CA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valuation of MgSO4 addition (2 and 10 </a:t>
            </a:r>
            <a:r>
              <a:rPr lang="en-CA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CA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gSO4) to the mobile phase for three different samples,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mely RNA ladder, EGFP mRNA (996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Cas9 mRNA (4521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6880937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B96E1CCD-AB96-4C02-AA1F-1334FCB80D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5213" y="1488600"/>
            <a:ext cx="9261573" cy="388080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66F98569-3827-42EC-A0FB-8E4325D39F94}"/>
              </a:ext>
            </a:extLst>
          </p:cNvPr>
          <p:cNvSpPr/>
          <p:nvPr/>
        </p:nvSpPr>
        <p:spPr>
          <a:xfrm>
            <a:off x="142" y="6211669"/>
            <a:ext cx="121918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CA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CA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Evaluation of acetonitrile addition (5 and 10% ACN) to the mobile phase for three different samples,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mely RNA ladder, EGFP mRNA (996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and Cas9 mRNA (4521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t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2721928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03DCAE97-734F-4CD0-85F0-BFAD01170E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4737" y="872837"/>
            <a:ext cx="7982526" cy="526255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7404A35F-B1F7-4683-AAB8-2161AC9B8B7D}"/>
              </a:ext>
            </a:extLst>
          </p:cNvPr>
          <p:cNvSpPr/>
          <p:nvPr/>
        </p:nvSpPr>
        <p:spPr>
          <a:xfrm>
            <a:off x="142" y="0"/>
            <a:ext cx="1219185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CA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CA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gration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imes for HMWS and LMWS of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tart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gration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end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gration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imes are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ntioned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is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able, for the 12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ce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in absence of MgCl</a:t>
            </a:r>
            <a:r>
              <a:rPr lang="fr-FR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fr-FR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66657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567940b-4f7f-4319-b0d3-ed94dee49aa8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BB8AD4BC28AE94C893BD116A66CF916" ma:contentTypeVersion="18" ma:contentTypeDescription="Crée un document." ma:contentTypeScope="" ma:versionID="e5fdf466ec28be0fd6a444d28261679d">
  <xsd:schema xmlns:xsd="http://www.w3.org/2001/XMLSchema" xmlns:xs="http://www.w3.org/2001/XMLSchema" xmlns:p="http://schemas.microsoft.com/office/2006/metadata/properties" xmlns:ns3="8567940b-4f7f-4319-b0d3-ed94dee49aa8" xmlns:ns4="fe6057ce-e3b4-41d5-ad06-85acbe41e534" targetNamespace="http://schemas.microsoft.com/office/2006/metadata/properties" ma:root="true" ma:fieldsID="62e08eff88a682b79916dd7cc2bda030" ns3:_="" ns4:_="">
    <xsd:import namespace="8567940b-4f7f-4319-b0d3-ed94dee49aa8"/>
    <xsd:import namespace="fe6057ce-e3b4-41d5-ad06-85acbe41e53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LengthInSeconds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567940b-4f7f-4319-b0d3-ed94dee49aa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4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6057ce-e3b4-41d5-ad06-85acbe41e534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AC2288F-881E-4859-9009-6189E9566904}">
  <ds:schemaRefs>
    <ds:schemaRef ds:uri="http://schemas.microsoft.com/office/2006/metadata/properties"/>
    <ds:schemaRef ds:uri="http://purl.org/dc/dcmitype/"/>
    <ds:schemaRef ds:uri="http://purl.org/dc/terms/"/>
    <ds:schemaRef ds:uri="http://purl.org/dc/elements/1.1/"/>
    <ds:schemaRef ds:uri="http://schemas.openxmlformats.org/package/2006/metadata/core-properties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fe6057ce-e3b4-41d5-ad06-85acbe41e534"/>
    <ds:schemaRef ds:uri="8567940b-4f7f-4319-b0d3-ed94dee49aa8"/>
  </ds:schemaRefs>
</ds:datastoreItem>
</file>

<file path=customXml/itemProps2.xml><?xml version="1.0" encoding="utf-8"?>
<ds:datastoreItem xmlns:ds="http://schemas.openxmlformats.org/officeDocument/2006/customXml" ds:itemID="{F8DAE797-6852-436B-AC10-A0AFA7D5FB1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567940b-4f7f-4319-b0d3-ed94dee49aa8"/>
    <ds:schemaRef ds:uri="fe6057ce-e3b4-41d5-ad06-85acbe41e53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96B7D2B-E20A-4355-8D91-489B92EE292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76</TotalTime>
  <Words>225</Words>
  <Application>Microsoft Office PowerPoint</Application>
  <PresentationFormat>Grand écran</PresentationFormat>
  <Paragraphs>8</Paragraphs>
  <Slides>5</Slides>
  <Notes>3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onorine Lardeux</dc:creator>
  <cp:lastModifiedBy>Davy Guillarme</cp:lastModifiedBy>
  <cp:revision>24</cp:revision>
  <dcterms:created xsi:type="dcterms:W3CDTF">2024-01-29T11:42:02Z</dcterms:created>
  <dcterms:modified xsi:type="dcterms:W3CDTF">2024-05-30T15:27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BB8AD4BC28AE94C893BD116A66CF916</vt:lpwstr>
  </property>
</Properties>
</file>